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-1694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8892" y="1991380"/>
            <a:ext cx="57145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b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RNA sequences used for interference of BTG2 expression in human cells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32"/>
          <p:cNvGrpSpPr/>
          <p:nvPr/>
        </p:nvGrpSpPr>
        <p:grpSpPr>
          <a:xfrm>
            <a:off x="140046" y="3100358"/>
            <a:ext cx="6260754" cy="2538442"/>
            <a:chOff x="140046" y="3729014"/>
            <a:chExt cx="6260754" cy="2538442"/>
          </a:xfrm>
        </p:grpSpPr>
        <p:cxnSp>
          <p:nvCxnSpPr>
            <p:cNvPr id="5" name="Straight Connector 44"/>
            <p:cNvCxnSpPr/>
            <p:nvPr/>
          </p:nvCxnSpPr>
          <p:spPr>
            <a:xfrm flipV="1">
              <a:off x="140046" y="6267456"/>
              <a:ext cx="62179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Connector 24"/>
            <p:cNvCxnSpPr/>
            <p:nvPr/>
          </p:nvCxnSpPr>
          <p:spPr>
            <a:xfrm flipV="1">
              <a:off x="182880" y="3729014"/>
              <a:ext cx="62179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25"/>
            <p:cNvCxnSpPr/>
            <p:nvPr/>
          </p:nvCxnSpPr>
          <p:spPr>
            <a:xfrm flipV="1">
              <a:off x="182880" y="4095744"/>
              <a:ext cx="62179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310606" y="3800452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 pitchFamily="18" charset="0"/>
                  <a:cs typeface="Times New Roman" pitchFamily="18" charset="0"/>
                </a:rPr>
                <a:t>siRNAs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033023" y="3800452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Sense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49771" y="3800452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 pitchFamily="18" charset="0"/>
                  <a:cs typeface="Times New Roman" pitchFamily="18" charset="0"/>
                </a:rPr>
                <a:t>Antisense</a:t>
              </a:r>
              <a:endParaRPr lang="en-US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Rectangle 29"/>
            <p:cNvSpPr/>
            <p:nvPr/>
          </p:nvSpPr>
          <p:spPr>
            <a:xfrm>
              <a:off x="256104" y="4248144"/>
              <a:ext cx="70403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hBTG2 #1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Rectangle 30"/>
            <p:cNvSpPr/>
            <p:nvPr/>
          </p:nvSpPr>
          <p:spPr>
            <a:xfrm>
              <a:off x="256104" y="4535323"/>
              <a:ext cx="70403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hBTG2 #2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Rectangle 31"/>
            <p:cNvSpPr/>
            <p:nvPr/>
          </p:nvSpPr>
          <p:spPr>
            <a:xfrm>
              <a:off x="256104" y="4840123"/>
              <a:ext cx="70403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hBTG2 #3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Rectangle 32"/>
            <p:cNvSpPr/>
            <p:nvPr/>
          </p:nvSpPr>
          <p:spPr>
            <a:xfrm>
              <a:off x="256104" y="5144923"/>
              <a:ext cx="70403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hBTG2 #4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Rectangle 33"/>
            <p:cNvSpPr/>
            <p:nvPr/>
          </p:nvSpPr>
          <p:spPr>
            <a:xfrm>
              <a:off x="256104" y="5449723"/>
              <a:ext cx="704039" cy="230832"/>
            </a:xfrm>
            <a:prstGeom prst="rect">
              <a:avLst/>
            </a:prstGeom>
          </p:spPr>
          <p:txBody>
            <a:bodyPr wrap="none" anchor="ctr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hBTG2 #5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Rectangle 34"/>
            <p:cNvSpPr/>
            <p:nvPr/>
          </p:nvSpPr>
          <p:spPr>
            <a:xfrm>
              <a:off x="1183431" y="4248144"/>
              <a:ext cx="215956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CUUAAACAAUACUAUGUUA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Rectangle 35"/>
            <p:cNvSpPr/>
            <p:nvPr/>
          </p:nvSpPr>
          <p:spPr>
            <a:xfrm>
              <a:off x="4093153" y="4248144"/>
              <a:ext cx="217239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UAACAUAGUAUUGUUUAAG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Rectangle 36"/>
            <p:cNvSpPr/>
            <p:nvPr/>
          </p:nvSpPr>
          <p:spPr>
            <a:xfrm>
              <a:off x="1177019" y="4535323"/>
              <a:ext cx="217239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GUAUGUGUGGCAAAUAAUU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Rectangle 37"/>
            <p:cNvSpPr/>
            <p:nvPr/>
          </p:nvSpPr>
          <p:spPr>
            <a:xfrm>
              <a:off x="4105977" y="4535323"/>
              <a:ext cx="214674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AAUUAUUUGCCACACAUAC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Rectangle 38"/>
            <p:cNvSpPr/>
            <p:nvPr/>
          </p:nvSpPr>
          <p:spPr>
            <a:xfrm>
              <a:off x="1180225" y="4840123"/>
              <a:ext cx="216597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GUAGACUUGUGCAAUAUAU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Rectangle 39"/>
            <p:cNvSpPr/>
            <p:nvPr/>
          </p:nvSpPr>
          <p:spPr>
            <a:xfrm>
              <a:off x="4102771" y="4840123"/>
              <a:ext cx="215315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AUAUAUUGCACAUGUCUAC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Rectangle 40"/>
            <p:cNvSpPr/>
            <p:nvPr/>
          </p:nvSpPr>
          <p:spPr>
            <a:xfrm>
              <a:off x="1183431" y="5144923"/>
              <a:ext cx="215956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GACUCAAAGGUGCUAUUUA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Rectangle 41"/>
            <p:cNvSpPr/>
            <p:nvPr/>
          </p:nvSpPr>
          <p:spPr>
            <a:xfrm>
              <a:off x="4102771" y="5144923"/>
              <a:ext cx="215315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UAAAUAGCACCUUUGAGUC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Rectangle 42"/>
            <p:cNvSpPr/>
            <p:nvPr/>
          </p:nvSpPr>
          <p:spPr>
            <a:xfrm>
              <a:off x="1183431" y="5449723"/>
              <a:ext cx="2159566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CAGCUUAUGGACAAAUGUA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Rectangle 43"/>
            <p:cNvSpPr/>
            <p:nvPr/>
          </p:nvSpPr>
          <p:spPr>
            <a:xfrm>
              <a:off x="4102771" y="5449723"/>
              <a:ext cx="2153154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 UACAUUUGUCCAUAAGCUGUU 3' 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00374" y="5735483"/>
              <a:ext cx="41549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Akt1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1104884" y="5735483"/>
              <a:ext cx="231666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-GAGUUUGAGUACCUGAAGCUGUU-3'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033842" y="5735483"/>
              <a:ext cx="229101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'-CAGCUUCAGGUACUCAAACUCUU-3'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71520" y="602123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TIS21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177019" y="6021235"/>
              <a:ext cx="21723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’-CCAUCUGUGUCCUGUAUGAUU-3’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089947" y="6021235"/>
              <a:ext cx="21788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Times New Roman" pitchFamily="18" charset="0"/>
                  <a:cs typeface="Times New Roman" pitchFamily="18" charset="0"/>
                </a:rPr>
                <a:t>5’-UCAUACAGGACACAGAUGGUU-3’</a:t>
              </a:r>
              <a:endParaRPr lang="en-US" sz="9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4" name="Rectangle 33"/>
          <p:cNvSpPr/>
          <p:nvPr/>
        </p:nvSpPr>
        <p:spPr>
          <a:xfrm>
            <a:off x="0" y="1718846"/>
            <a:ext cx="172675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6:</a:t>
            </a:r>
            <a:endParaRPr lang="en-US" sz="2800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1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eethi</dc:creator>
  <cp:lastModifiedBy>preet</cp:lastModifiedBy>
  <cp:revision>2</cp:revision>
  <dcterms:created xsi:type="dcterms:W3CDTF">2006-08-16T00:00:00Z</dcterms:created>
  <dcterms:modified xsi:type="dcterms:W3CDTF">2013-08-24T15:34:47Z</dcterms:modified>
</cp:coreProperties>
</file>